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9906000" cy="6858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114" d="100"/>
          <a:sy n="114" d="100"/>
        </p:scale>
        <p:origin x="1276" y="64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24CFC3-9178-4FA3-96A9-1557554E1580}" type="datetimeFigureOut">
              <a:rPr lang="zh-CN" altLang="en-US" smtClean="0"/>
              <a:t>2021/8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9BDC8-0B2B-4856-B146-9B39BF6733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848447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24CFC3-9178-4FA3-96A9-1557554E1580}" type="datetimeFigureOut">
              <a:rPr lang="zh-CN" altLang="en-US" smtClean="0"/>
              <a:t>2021/8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9BDC8-0B2B-4856-B146-9B39BF6733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53285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24CFC3-9178-4FA3-96A9-1557554E1580}" type="datetimeFigureOut">
              <a:rPr lang="zh-CN" altLang="en-US" smtClean="0"/>
              <a:t>2021/8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9BDC8-0B2B-4856-B146-9B39BF6733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66998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24CFC3-9178-4FA3-96A9-1557554E1580}" type="datetimeFigureOut">
              <a:rPr lang="zh-CN" altLang="en-US" smtClean="0"/>
              <a:t>2021/8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9BDC8-0B2B-4856-B146-9B39BF6733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60877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24CFC3-9178-4FA3-96A9-1557554E1580}" type="datetimeFigureOut">
              <a:rPr lang="zh-CN" altLang="en-US" smtClean="0"/>
              <a:t>2021/8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9BDC8-0B2B-4856-B146-9B39BF6733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86734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24CFC3-9178-4FA3-96A9-1557554E1580}" type="datetimeFigureOut">
              <a:rPr lang="zh-CN" altLang="en-US" smtClean="0"/>
              <a:t>2021/8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9BDC8-0B2B-4856-B146-9B39BF6733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39551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24CFC3-9178-4FA3-96A9-1557554E1580}" type="datetimeFigureOut">
              <a:rPr lang="zh-CN" altLang="en-US" smtClean="0"/>
              <a:t>2021/8/2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9BDC8-0B2B-4856-B146-9B39BF6733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53619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24CFC3-9178-4FA3-96A9-1557554E1580}" type="datetimeFigureOut">
              <a:rPr lang="zh-CN" altLang="en-US" smtClean="0"/>
              <a:t>2021/8/2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9BDC8-0B2B-4856-B146-9B39BF6733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526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24CFC3-9178-4FA3-96A9-1557554E1580}" type="datetimeFigureOut">
              <a:rPr lang="zh-CN" altLang="en-US" smtClean="0"/>
              <a:t>2021/8/2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9BDC8-0B2B-4856-B146-9B39BF6733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407846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24CFC3-9178-4FA3-96A9-1557554E1580}" type="datetimeFigureOut">
              <a:rPr lang="zh-CN" altLang="en-US" smtClean="0"/>
              <a:t>2021/8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9BDC8-0B2B-4856-B146-9B39BF6733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0132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24CFC3-9178-4FA3-96A9-1557554E1580}" type="datetimeFigureOut">
              <a:rPr lang="zh-CN" altLang="en-US" smtClean="0"/>
              <a:t>2021/8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9BDC8-0B2B-4856-B146-9B39BF6733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113021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24CFC3-9178-4FA3-96A9-1557554E1580}" type="datetimeFigureOut">
              <a:rPr lang="zh-CN" altLang="en-US" smtClean="0"/>
              <a:t>2021/8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E9BDC8-0B2B-4856-B146-9B39BF6733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811162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E1323E82-444E-4434-9E74-EBE7C1E67E44}"/>
              </a:ext>
            </a:extLst>
          </p:cNvPr>
          <p:cNvSpPr txBox="1"/>
          <p:nvPr/>
        </p:nvSpPr>
        <p:spPr>
          <a:xfrm>
            <a:off x="301895" y="104765"/>
            <a:ext cx="9302205" cy="89011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200" b="1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Supplementary Figure S2. 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The free Ca</a:t>
            </a:r>
            <a:r>
              <a:rPr lang="en-US" altLang="zh-CN" sz="1200" baseline="300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2+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levels in pulp cells in apples with bitter pit were detected using the potassium pyroantimonate precipitation method. There was abundant Ca</a:t>
            </a:r>
            <a:r>
              <a:rPr lang="en-US" altLang="zh-CN" sz="1200" baseline="300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2+ 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granular precipitation on the vacuole membrane (A and B) and flocculent Ca</a:t>
            </a:r>
            <a:r>
              <a:rPr lang="en-US" altLang="zh-CN" sz="1200" baseline="300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2+ 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precipitation in the vacuole (C and D). The white arrow indicates Ca</a:t>
            </a:r>
            <a:r>
              <a:rPr lang="en-US" altLang="zh-CN" sz="1200" baseline="300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2+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precipitation. </a:t>
            </a:r>
            <a:r>
              <a:rPr lang="en-US" altLang="zh-CN" sz="12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Cw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, cell wall; M, mitochondria; </a:t>
            </a:r>
            <a:r>
              <a:rPr lang="en-US" altLang="zh-CN" sz="12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Cyt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, cytoplasm; V, vacuole.</a:t>
            </a:r>
            <a:endParaRPr lang="zh-CN" altLang="zh-CN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3" name="图片 2" descr="图片包含 照片, 雨, 侧面, 男人&#10;&#10;描述已自动生成">
            <a:extLst>
              <a:ext uri="{FF2B5EF4-FFF2-40B4-BE49-F238E27FC236}">
                <a16:creationId xmlns:a16="http://schemas.microsoft.com/office/drawing/2014/main" id="{F970B9CE-E5D8-45A8-ABF2-20C0E9FCAAB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5995" y="994880"/>
            <a:ext cx="7734003" cy="57820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274187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82</TotalTime>
  <Words>80</Words>
  <Application>Microsoft Office PowerPoint</Application>
  <PresentationFormat>A4 纸张(210x297 毫米)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qu haiyong</dc:creator>
  <cp:lastModifiedBy>qu haiyong</cp:lastModifiedBy>
  <cp:revision>8</cp:revision>
  <dcterms:created xsi:type="dcterms:W3CDTF">2020-11-13T07:20:27Z</dcterms:created>
  <dcterms:modified xsi:type="dcterms:W3CDTF">2021-08-21T17:51:31Z</dcterms:modified>
</cp:coreProperties>
</file>